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362" r:id="rId2"/>
    <p:sldId id="392" r:id="rId3"/>
    <p:sldId id="393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75C61E-B2E1-41AA-96AD-9419A7712B5C}" type="datetimeFigureOut">
              <a:rPr lang="zh-CN" altLang="en-US" smtClean="0"/>
              <a:t>2022/9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B4080F-703D-4F40-8252-AA3F8B89FE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81355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908A75E-F467-E9D3-EB8B-267576E19F6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E837999-E469-D449-DF83-2934149ED1A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C1C1DF4-5FF6-535A-8F32-27540EBF2D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63C18-5E3A-45C6-A220-4CA5A59D3459}" type="datetimeFigureOut">
              <a:rPr lang="zh-CN" altLang="en-US" smtClean="0"/>
              <a:t>2022/9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32A472B-33E3-F25C-DA64-82F7D52E0D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A83DBF2-3E80-7101-1A25-3300317569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94446-1FC6-4F3C-B880-62F8FC1500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21022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08D9C1-DC01-5184-47F0-427F0A0732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817AAE0-9812-0110-80B0-800AF79C9D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F69989B-927C-9CFB-AE5E-275FEA988F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63C18-5E3A-45C6-A220-4CA5A59D3459}" type="datetimeFigureOut">
              <a:rPr lang="zh-CN" altLang="en-US" smtClean="0"/>
              <a:t>2022/9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1BB11B3-BFCE-72EA-7DFC-CB9FBCBB25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A7B656B-1A90-CBB7-BD49-B004BBD7A3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94446-1FC6-4F3C-B880-62F8FC1500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00698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92D6085-2D87-7E7D-946A-F3BEEA860AE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EC0A142-DE07-5956-3077-84AD350DB9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DBA64A9-D9DA-1E25-E0C2-E6266E86F1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63C18-5E3A-45C6-A220-4CA5A59D3459}" type="datetimeFigureOut">
              <a:rPr lang="zh-CN" altLang="en-US" smtClean="0"/>
              <a:t>2022/9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3D12700-C8A9-C4AB-8403-1FE3610048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1EAFC2C-9AF1-396E-AF24-C875C3B728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94446-1FC6-4F3C-B880-62F8FC1500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83416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6A955BE-BB4C-BDE7-2259-567AC60E0F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B1C5611-19F7-D35C-907E-EBB334C5BA2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9A0A60B-46DA-4868-6781-025CA4FA74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63C18-5E3A-45C6-A220-4CA5A59D3459}" type="datetimeFigureOut">
              <a:rPr lang="zh-CN" altLang="en-US" smtClean="0"/>
              <a:t>2022/9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C13674B-0067-69CD-EDF4-7D1CA6E826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4F0951B-C50C-189B-8C70-A586E6CC79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94446-1FC6-4F3C-B880-62F8FC1500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28087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B7C5C45-5FFF-3EFF-5A86-1C51F65B7E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E3DB985-85A2-7CA1-ED44-6D1869D98A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8B63190-4176-82F3-EA2D-953DFE19BA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63C18-5E3A-45C6-A220-4CA5A59D3459}" type="datetimeFigureOut">
              <a:rPr lang="zh-CN" altLang="en-US" smtClean="0"/>
              <a:t>2022/9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561DCE8-E514-04E3-6D97-E2E7C8FD17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EAD2857-D25E-A171-9AEC-5D397752B0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94446-1FC6-4F3C-B880-62F8FC1500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18209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33338D6-2117-6BD7-B6B2-37F6F270B4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460DF45-AF1F-6039-FE5D-EE41481FEDB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F038CEB-EBA8-CA70-8B5F-F7B7EA3A3B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BAEDA81-4397-61F5-0DFC-25ACA77D5A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63C18-5E3A-45C6-A220-4CA5A59D3459}" type="datetimeFigureOut">
              <a:rPr lang="zh-CN" altLang="en-US" smtClean="0"/>
              <a:t>2022/9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7D34009-EB06-FC09-6B50-1E7560A01A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D17D51A-E19C-137C-C86D-1572EB4DCE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94446-1FC6-4F3C-B880-62F8FC1500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66318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5F90D5C-38AE-90A1-9B92-ECE67F2F70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B6C1154-64FA-2281-CAE0-A07BA0DCFD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58CBDD3-687E-E1AD-C11A-8D4E0DF97B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2DE2994-EC7B-CD30-3953-64A1E99E462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4251AE8-E503-D273-DBD7-A27492F58F9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9BC09E7-45D0-922C-0978-BC312121E4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63C18-5E3A-45C6-A220-4CA5A59D3459}" type="datetimeFigureOut">
              <a:rPr lang="zh-CN" altLang="en-US" smtClean="0"/>
              <a:t>2022/9/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A83C8D6-322B-3C0B-384B-86B699EDD3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57ADD9C-D280-775E-1B79-9FD32B1A12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94446-1FC6-4F3C-B880-62F8FC1500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0674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2ECA980-4ACA-7A6B-7EC8-2F2EBBD4F5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1AE260C-BC1C-4C22-5475-418CEF5B42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63C18-5E3A-45C6-A220-4CA5A59D3459}" type="datetimeFigureOut">
              <a:rPr lang="zh-CN" altLang="en-US" smtClean="0"/>
              <a:t>2022/9/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8551839-4D00-515E-53C7-4466817BFD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BD748AC-BB78-69FE-E769-0B88244F92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94446-1FC6-4F3C-B880-62F8FC1500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17641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2032523-74A6-A6B1-814F-0749A3E1C5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63C18-5E3A-45C6-A220-4CA5A59D3459}" type="datetimeFigureOut">
              <a:rPr lang="zh-CN" altLang="en-US" smtClean="0"/>
              <a:t>2022/9/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6C4F600-268B-B55F-3303-072E34CDF7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4FD0BF7-B8DF-82E3-39CC-1D762BA072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94446-1FC6-4F3C-B880-62F8FC1500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9132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D8A4FF-ECE6-B1CC-E72D-4E3BDDB11F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6718CD8-3345-CC01-0A10-E9674180E91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1F28443-104C-FE9D-8DEE-6C9744C7C3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C9325AD-AA17-6F8E-769E-0E49F9AC02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63C18-5E3A-45C6-A220-4CA5A59D3459}" type="datetimeFigureOut">
              <a:rPr lang="zh-CN" altLang="en-US" smtClean="0"/>
              <a:t>2022/9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8C1AE93-A072-DFAB-86B1-8CD6673493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F3E85AC-B12B-B777-1D82-85950F0253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94446-1FC6-4F3C-B880-62F8FC1500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8227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877CDB-E5BF-569B-7C68-A0530CFC14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143967F-8E85-F9F5-F727-260671DA265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71E874E-CE86-6C59-0318-78DA121B66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DB166DE-77F9-E995-0779-7D8499C74C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63C18-5E3A-45C6-A220-4CA5A59D3459}" type="datetimeFigureOut">
              <a:rPr lang="zh-CN" altLang="en-US" smtClean="0"/>
              <a:t>2022/9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E6E5500-BFA7-FAF1-5A67-C869E98EF1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C12DF81-3233-E33B-42DF-8FC06BF89B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94446-1FC6-4F3C-B880-62F8FC1500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18185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A6CC166-35E8-5828-D419-F1B5D16465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CB53D52-1C25-AAB1-C004-C1506D5608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3A917B7-A56E-21E1-1955-CEC5C398589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163C18-5E3A-45C6-A220-4CA5A59D3459}" type="datetimeFigureOut">
              <a:rPr lang="zh-CN" altLang="en-US" smtClean="0"/>
              <a:t>2022/9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5C7CD7F-3006-E6D9-3024-D064E6A7DDC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7B05E69-2744-8F83-61AE-F9DA512B6FE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B94446-1FC6-4F3C-B880-62F8FC1500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2486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E28C4CE1-5A07-4567-A581-437451FDAE54}"/>
              </a:ext>
            </a:extLst>
          </p:cNvPr>
          <p:cNvSpPr txBox="1"/>
          <p:nvPr/>
        </p:nvSpPr>
        <p:spPr>
          <a:xfrm>
            <a:off x="200189" y="5568714"/>
            <a:ext cx="115824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b="1" i="0" u="none" strike="noStrike" baseline="0" dirty="0">
                <a:latin typeface="Calibri" panose="020F0502020204030204" pitchFamily="34" charset="0"/>
                <a:cs typeface="Calibri" panose="020F0502020204030204" pitchFamily="34" charset="0"/>
              </a:rPr>
              <a:t>Supplementary Figure S1.  </a:t>
            </a:r>
            <a:r>
              <a:rPr lang="en-US" altLang="zh-CN" sz="1400" i="0" u="none" strike="noStrike" baseline="0" dirty="0">
                <a:latin typeface="Calibri" panose="020F0502020204030204" pitchFamily="34" charset="0"/>
                <a:cs typeface="Calibri" panose="020F0502020204030204" pitchFamily="34" charset="0"/>
              </a:rPr>
              <a:t>Sequence comparisons for </a:t>
            </a:r>
            <a:r>
              <a:rPr lang="en-US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Cold Box Factor 4 (CBF4) from </a:t>
            </a:r>
            <a:r>
              <a:rPr lang="en-US" altLang="zh-CN" sz="1400" i="1" dirty="0">
                <a:latin typeface="Calibri" panose="020F0502020204030204" pitchFamily="34" charset="0"/>
                <a:cs typeface="Calibri" panose="020F0502020204030204" pitchFamily="34" charset="0"/>
              </a:rPr>
              <a:t>Vitis vinifera. </a:t>
            </a:r>
            <a:r>
              <a:rPr lang="en-US" altLang="zh-CN" sz="1400" b="1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US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 Phylogenetic relationship between CBF4 from different varieties of V. </a:t>
            </a:r>
            <a:r>
              <a:rPr lang="en-US" altLang="zh-CN" sz="1400" i="1" dirty="0">
                <a:latin typeface="Calibri" panose="020F0502020204030204" pitchFamily="34" charset="0"/>
                <a:cs typeface="Calibri" panose="020F0502020204030204" pitchFamily="34" charset="0"/>
              </a:rPr>
              <a:t>vinifera</a:t>
            </a:r>
            <a:r>
              <a:rPr lang="en-US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 (yellow circles) along with some wild species of </a:t>
            </a:r>
            <a:r>
              <a:rPr lang="en-US" altLang="zh-CN" sz="1400" i="1" dirty="0">
                <a:latin typeface="Calibri" panose="020F0502020204030204" pitchFamily="34" charset="0"/>
                <a:cs typeface="Calibri" panose="020F0502020204030204" pitchFamily="34" charset="0"/>
              </a:rPr>
              <a:t>Vitis</a:t>
            </a:r>
            <a:r>
              <a:rPr lang="en-US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, compared to the other CBF proteins from </a:t>
            </a:r>
            <a:r>
              <a:rPr lang="en-US" altLang="zh-CN" sz="1400" i="1" dirty="0">
                <a:latin typeface="Calibri" panose="020F0502020204030204" pitchFamily="34" charset="0"/>
                <a:cs typeface="Calibri" panose="020F0502020204030204" pitchFamily="34" charset="0"/>
              </a:rPr>
              <a:t>V. vinifera</a:t>
            </a:r>
            <a:r>
              <a:rPr lang="en-US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 cv. Pinot Noir as outgroup (blue circle). </a:t>
            </a:r>
            <a:r>
              <a:rPr lang="en-US" altLang="zh-CN" sz="1400" b="1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US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 Alignment of the CBFs from </a:t>
            </a:r>
            <a:r>
              <a:rPr lang="en-US" altLang="zh-CN" sz="1400" i="1" dirty="0">
                <a:latin typeface="Calibri" panose="020F0502020204030204" pitchFamily="34" charset="0"/>
                <a:cs typeface="Calibri" panose="020F0502020204030204" pitchFamily="34" charset="0"/>
              </a:rPr>
              <a:t>V. vinifera</a:t>
            </a:r>
            <a:r>
              <a:rPr lang="en-US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 cv. Pinot Noir. Identities are highlighted in black, similarities in magenta. </a:t>
            </a:r>
            <a:r>
              <a:rPr lang="en-US" altLang="zh-CN" sz="1400" u="none" strike="noStrike" baseline="0" dirty="0">
                <a:latin typeface="Calibri" panose="020F0502020204030204" pitchFamily="34" charset="0"/>
                <a:cs typeface="Calibri" panose="020F0502020204030204" pitchFamily="34" charset="0"/>
              </a:rPr>
              <a:t>The AP2/ERF DNA-binding domain is marked by the green rectangle, while the orange rectangles indicate the predicted nuclear </a:t>
            </a:r>
            <a:r>
              <a:rPr lang="en-US" altLang="zh-CN" sz="1400" u="none" strike="noStrike" baseline="0" dirty="0" err="1">
                <a:latin typeface="Calibri" panose="020F0502020204030204" pitchFamily="34" charset="0"/>
                <a:cs typeface="Calibri" panose="020F0502020204030204" pitchFamily="34" charset="0"/>
              </a:rPr>
              <a:t>localisation</a:t>
            </a:r>
            <a:r>
              <a:rPr lang="en-US" altLang="zh-CN" sz="1400" u="none" strike="noStrike" baseline="0" dirty="0">
                <a:latin typeface="Calibri" panose="020F0502020204030204" pitchFamily="34" charset="0"/>
                <a:cs typeface="Calibri" panose="020F0502020204030204" pitchFamily="34" charset="0"/>
              </a:rPr>
              <a:t> signals (NLS).</a:t>
            </a:r>
            <a:endParaRPr lang="zh-CN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87D34666-6AE5-4D62-8F41-10D4A2794145}"/>
              </a:ext>
            </a:extLst>
          </p:cNvPr>
          <p:cNvSpPr txBox="1"/>
          <p:nvPr/>
        </p:nvSpPr>
        <p:spPr>
          <a:xfrm>
            <a:off x="1904378" y="610529"/>
            <a:ext cx="6718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A</a:t>
            </a:r>
            <a:endParaRPr lang="zh-CN" altLang="en-US" b="1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B7392B65-9429-4033-81CC-3D074E6631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84195"/>
            <a:ext cx="4085742" cy="3288397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F6AB960B-2A69-4463-A3E0-6292C7943A29}"/>
              </a:ext>
            </a:extLst>
          </p:cNvPr>
          <p:cNvSpPr txBox="1"/>
          <p:nvPr/>
        </p:nvSpPr>
        <p:spPr>
          <a:xfrm>
            <a:off x="8106260" y="610529"/>
            <a:ext cx="6718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B</a:t>
            </a:r>
            <a:endParaRPr lang="zh-CN" altLang="en-US" b="1" dirty="0"/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8E318986-34E8-B3D1-2872-4AD188EB4FB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59946" y="1352827"/>
            <a:ext cx="8405100" cy="14248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196946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>
            <a:extLst>
              <a:ext uri="{FF2B5EF4-FFF2-40B4-BE49-F238E27FC236}">
                <a16:creationId xmlns:a16="http://schemas.microsoft.com/office/drawing/2014/main" id="{542006C2-887C-44CE-A899-740F326081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77669" y="0"/>
            <a:ext cx="3573266" cy="2921695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9D47D8D8-65B6-403F-8D28-B3E8B3389C2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858" t="5522" r="4733" b="3593"/>
          <a:stretch/>
        </p:blipFill>
        <p:spPr>
          <a:xfrm>
            <a:off x="80177" y="3015268"/>
            <a:ext cx="7178284" cy="3385532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B6BD32B1-6B8E-465F-96DF-364BDC2D254F}"/>
              </a:ext>
            </a:extLst>
          </p:cNvPr>
          <p:cNvSpPr txBox="1"/>
          <p:nvPr/>
        </p:nvSpPr>
        <p:spPr>
          <a:xfrm>
            <a:off x="80177" y="0"/>
            <a:ext cx="6718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A</a:t>
            </a:r>
            <a:endParaRPr lang="zh-CN" altLang="en-US" b="1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0A416C3E-B8A9-4B11-8AAD-0DF70BCE75F7}"/>
              </a:ext>
            </a:extLst>
          </p:cNvPr>
          <p:cNvSpPr txBox="1"/>
          <p:nvPr/>
        </p:nvSpPr>
        <p:spPr>
          <a:xfrm>
            <a:off x="80177" y="2921695"/>
            <a:ext cx="6718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B</a:t>
            </a:r>
            <a:endParaRPr lang="zh-CN" altLang="en-US" b="1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E0BA0FFE-2009-4EBD-A14C-EBDB37045A2B}"/>
              </a:ext>
            </a:extLst>
          </p:cNvPr>
          <p:cNvSpPr txBox="1"/>
          <p:nvPr/>
        </p:nvSpPr>
        <p:spPr>
          <a:xfrm>
            <a:off x="7258461" y="3429000"/>
            <a:ext cx="4788537" cy="33239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</a:t>
            </a:r>
            <a:r>
              <a:rPr lang="en-US" altLang="zh-CN" sz="1400" b="1">
                <a:latin typeface="Calibri" panose="020F0502020204030204" pitchFamily="34" charset="0"/>
                <a:cs typeface="Calibri" panose="020F0502020204030204" pitchFamily="34" charset="0"/>
              </a:rPr>
              <a:t>Figure S2. </a:t>
            </a:r>
            <a:r>
              <a:rPr lang="en-US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Time-course of </a:t>
            </a:r>
            <a:r>
              <a:rPr lang="en-US" altLang="zh-CN" sz="1400" b="1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US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zh-CN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apoplastic</a:t>
            </a:r>
            <a:r>
              <a:rPr lang="en-US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 alkalinization as proxy for calcium influx, and </a:t>
            </a:r>
            <a:r>
              <a:rPr lang="en-US" altLang="zh-CN" sz="1400" b="1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US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 mitochondrial superoxide accumulation as measured by </a:t>
            </a:r>
            <a:r>
              <a:rPr lang="en-US" altLang="zh-CN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MitoSOX</a:t>
            </a:r>
            <a:r>
              <a:rPr lang="en-US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 fluorescence in response to freezing stress (0°C) in either non-transformed tobacco BY-2 cells (WT) and cells overexpressing CBF4 from grapevine (VvCBF4ox). </a:t>
            </a:r>
            <a:r>
              <a:rPr lang="de-DE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The </a:t>
            </a:r>
            <a:r>
              <a:rPr lang="de-DE" altLang="zh-CN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cold</a:t>
            </a:r>
            <a:r>
              <a:rPr lang="de-DE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 stress in </a:t>
            </a:r>
            <a:r>
              <a:rPr lang="de-DE" altLang="zh-CN" sz="1400" b="1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de-DE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altLang="zh-CN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lasted</a:t>
            </a:r>
            <a:r>
              <a:rPr lang="de-DE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altLang="zh-CN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for</a:t>
            </a:r>
            <a:r>
              <a:rPr lang="de-DE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 2 h (</a:t>
            </a:r>
            <a:r>
              <a:rPr lang="de-DE" altLang="zh-CN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dashed</a:t>
            </a:r>
            <a:r>
              <a:rPr lang="de-DE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altLang="zh-CN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line</a:t>
            </a:r>
            <a:r>
              <a:rPr lang="de-DE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), </a:t>
            </a:r>
            <a:r>
              <a:rPr lang="de-DE" altLang="zh-CN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before</a:t>
            </a:r>
            <a:r>
              <a:rPr lang="de-DE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altLang="zh-CN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cells</a:t>
            </a:r>
            <a:r>
              <a:rPr lang="de-DE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altLang="zh-CN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were</a:t>
            </a:r>
            <a:r>
              <a:rPr lang="de-DE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altLang="zh-CN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returned</a:t>
            </a:r>
            <a:r>
              <a:rPr lang="de-DE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altLang="zh-CN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to</a:t>
            </a:r>
            <a:r>
              <a:rPr lang="de-DE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 25°C </a:t>
            </a:r>
            <a:r>
              <a:rPr lang="de-DE" altLang="zh-CN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for</a:t>
            </a:r>
            <a:r>
              <a:rPr lang="de-DE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altLang="zh-CN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recovery</a:t>
            </a:r>
            <a:r>
              <a:rPr lang="de-DE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. </a:t>
            </a:r>
            <a:r>
              <a:rPr lang="en-US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Data represent mean ± SE from five independent experiments. Asterisk represents a statistically significant difference with LSD test (** </a:t>
            </a:r>
            <a:r>
              <a:rPr lang="en-US" altLang="zh-CN" sz="1400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 &lt;0.01). Relative fluorescence in </a:t>
            </a:r>
            <a:r>
              <a:rPr lang="en-US" altLang="zh-CN" sz="1400" b="1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US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 was recorded at a constant exposure time (600 </a:t>
            </a:r>
            <a:r>
              <a:rPr lang="en-US" altLang="zh-CN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ms</a:t>
            </a:r>
            <a:r>
              <a:rPr lang="en-US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) and </a:t>
            </a:r>
            <a:r>
              <a:rPr lang="en-US" altLang="zh-CN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normalised</a:t>
            </a:r>
            <a:r>
              <a:rPr lang="en-US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 to respective base fluorescence at 25°C. Data represent mean ± SE from three independent experiments comprising at least 500 individual cells. </a:t>
            </a:r>
          </a:p>
          <a:p>
            <a:endParaRPr lang="en-US" altLang="zh-CN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6BD09448-295E-48BF-9FDD-9EEBAB846218}"/>
              </a:ext>
            </a:extLst>
          </p:cNvPr>
          <p:cNvSpPr txBox="1"/>
          <p:nvPr/>
        </p:nvSpPr>
        <p:spPr>
          <a:xfrm>
            <a:off x="7775601" y="0"/>
            <a:ext cx="357326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i="0" u="none" strike="noStrike" baseline="0" dirty="0">
                <a:latin typeface="TimesTen-Roman"/>
              </a:rPr>
              <a:t>Supplementary Data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1141602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72A6685B-A718-A78B-BD84-7451F0D462C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9092183"/>
              </p:ext>
            </p:extLst>
          </p:nvPr>
        </p:nvGraphicFramePr>
        <p:xfrm>
          <a:off x="378690" y="296035"/>
          <a:ext cx="11545455" cy="519820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911928">
                  <a:extLst>
                    <a:ext uri="{9D8B030D-6E8A-4147-A177-3AD203B41FA5}">
                      <a16:colId xmlns:a16="http://schemas.microsoft.com/office/drawing/2014/main" val="1103633890"/>
                    </a:ext>
                  </a:extLst>
                </a:gridCol>
                <a:gridCol w="877454">
                  <a:extLst>
                    <a:ext uri="{9D8B030D-6E8A-4147-A177-3AD203B41FA5}">
                      <a16:colId xmlns:a16="http://schemas.microsoft.com/office/drawing/2014/main" val="2796896200"/>
                    </a:ext>
                  </a:extLst>
                </a:gridCol>
                <a:gridCol w="1339273">
                  <a:extLst>
                    <a:ext uri="{9D8B030D-6E8A-4147-A177-3AD203B41FA5}">
                      <a16:colId xmlns:a16="http://schemas.microsoft.com/office/drawing/2014/main" val="2590405520"/>
                    </a:ext>
                  </a:extLst>
                </a:gridCol>
                <a:gridCol w="6585528">
                  <a:extLst>
                    <a:ext uri="{9D8B030D-6E8A-4147-A177-3AD203B41FA5}">
                      <a16:colId xmlns:a16="http://schemas.microsoft.com/office/drawing/2014/main" val="3994714388"/>
                    </a:ext>
                  </a:extLst>
                </a:gridCol>
                <a:gridCol w="831272">
                  <a:extLst>
                    <a:ext uri="{9D8B030D-6E8A-4147-A177-3AD203B41FA5}">
                      <a16:colId xmlns:a16="http://schemas.microsoft.com/office/drawing/2014/main" val="7078936"/>
                    </a:ext>
                  </a:extLst>
                </a:gridCol>
              </a:tblGrid>
              <a:tr h="443327"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plication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</a:t>
                      </a:r>
                      <a:r>
                        <a:rPr lang="zh-CN" sz="12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℃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8947941"/>
                  </a:ext>
                </a:extLst>
              </a:tr>
              <a:tr h="152476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ne of full-length cDNA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i="1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vCBF4 </a:t>
                      </a:r>
                      <a:endParaRPr lang="zh-CN" sz="1200" i="1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GAATACTACTTCTCCACC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54079664"/>
                  </a:ext>
                </a:extLst>
              </a:tr>
              <a:tr h="15380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TAGAGTAACTCCATAACG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7188714"/>
                  </a:ext>
                </a:extLst>
              </a:tr>
              <a:tr h="175344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TEWAY clone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i="1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vCBF4 </a:t>
                      </a:r>
                    </a:p>
                    <a:p>
                      <a:pPr algn="ctr"/>
                      <a:r>
                        <a:rPr lang="en-US" sz="1200" i="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-terminal</a:t>
                      </a:r>
                      <a:endParaRPr lang="zh-CN" sz="1200" i="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GGACAAGTTTGTACAAAAAAGCAGGCTTCATGAATACTACTTCTCCACCATATTC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83580031"/>
                  </a:ext>
                </a:extLst>
              </a:tr>
              <a:tr h="14027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GGACCACTTTGTACAAGAAAGCTGGGTCAATAGAGTAACTCCATAACGACA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5424279"/>
                  </a:ext>
                </a:extLst>
              </a:tr>
              <a:tr h="115726">
                <a:tc rowSpan="22"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T-qPCR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i="1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L25</a:t>
                      </a:r>
                      <a:endParaRPr lang="zh-CN" sz="1200" i="1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TGCCAAGGCTGTCAAGTCAGG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-61.5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05636363"/>
                  </a:ext>
                </a:extLst>
              </a:tr>
              <a:tr h="16605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ACTAATACGAGGGTACTTGGGG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09823690"/>
                  </a:ext>
                </a:extLst>
              </a:tr>
              <a:tr h="15247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i="1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vCBF4</a:t>
                      </a:r>
                      <a:endParaRPr lang="zh-CN" sz="1200" i="1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GCGTTTAGGCCAATGGAG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5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92383162"/>
                  </a:ext>
                </a:extLst>
              </a:tr>
              <a:tr h="15247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CACATTATCCGGCGTCCT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683629"/>
                  </a:ext>
                </a:extLst>
              </a:tr>
              <a:tr h="15247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i="1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r9/Cf9</a:t>
                      </a:r>
                      <a:endParaRPr lang="zh-CN" sz="1200" i="1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GAGGAATTCAGACAAGTG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31021640"/>
                  </a:ext>
                </a:extLst>
              </a:tr>
              <a:tr h="15247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AGTTCAAGCAAGCAGAAC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13382740"/>
                  </a:ext>
                </a:extLst>
              </a:tr>
              <a:tr h="15247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i="1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DREB1</a:t>
                      </a:r>
                      <a:endParaRPr lang="zh-CN" sz="1200" i="1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GGTAAGTGGGTGTGTGAAGTG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5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37275203"/>
                  </a:ext>
                </a:extLst>
              </a:tr>
              <a:tr h="15247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CGATCTCGGCTGTTAGG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89420400"/>
                  </a:ext>
                </a:extLst>
              </a:tr>
              <a:tr h="15247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i="1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DREB3</a:t>
                      </a:r>
                      <a:endParaRPr lang="zh-CN" sz="1200" i="1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CAGGGGAGTGAGGAAGAGGA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5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79000367"/>
                  </a:ext>
                </a:extLst>
              </a:tr>
              <a:tr h="15247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AGAAGGGAAAGTGCCAAG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8842936"/>
                  </a:ext>
                </a:extLst>
              </a:tr>
              <a:tr h="15247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i="1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ERD10a</a:t>
                      </a:r>
                      <a:endParaRPr lang="zh-CN" sz="1200" i="1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AGAAGAAGGGAATTATGGACAAG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5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3667690"/>
                  </a:ext>
                </a:extLst>
              </a:tr>
              <a:tr h="15247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CAGCAGATTTTCTAGTGGTG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1673922"/>
                  </a:ext>
                </a:extLst>
              </a:tr>
              <a:tr h="15247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i="1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ERD10c</a:t>
                      </a:r>
                      <a:endParaRPr lang="zh-CN" sz="1200" i="1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ACAAACTCAGAGGAAATAG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44145384"/>
                  </a:ext>
                </a:extLst>
              </a:tr>
              <a:tr h="15247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CGAGGGAAGAAGAGAAGG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1051866"/>
                  </a:ext>
                </a:extLst>
              </a:tr>
              <a:tr h="15247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i="1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ERD10d</a:t>
                      </a:r>
                      <a:endParaRPr lang="zh-CN" sz="1200" i="1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GGACACGGCTGTACCAGT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5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48101163"/>
                  </a:ext>
                </a:extLst>
              </a:tr>
              <a:tr h="15247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GCCACTTCCTCTGTCTT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4761798"/>
                  </a:ext>
                </a:extLst>
              </a:tr>
              <a:tr h="152476"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i="1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tis actin</a:t>
                      </a:r>
                      <a:endParaRPr lang="zh-CN" sz="1200" i="1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CTATATGCCAGTGGGCGTAC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-61.5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62612462"/>
                  </a:ext>
                </a:extLst>
              </a:tr>
              <a:tr h="15247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AGGAGCTGCTCTTTGCAG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28965015"/>
                  </a:ext>
                </a:extLst>
              </a:tr>
              <a:tr h="15247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i="1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CBF4</a:t>
                      </a:r>
                      <a:endParaRPr lang="zh-CN" sz="1200" i="1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TTCCCTGAATTTGCCTGA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0846059"/>
                  </a:ext>
                </a:extLst>
              </a:tr>
              <a:tr h="15247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TCTTCCTCCCAGCTCGT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27653394"/>
                  </a:ext>
                </a:extLst>
              </a:tr>
              <a:tr h="15247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i="1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cCBF4</a:t>
                      </a:r>
                      <a:endParaRPr lang="zh-CN" sz="1200" i="1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AGGTAAGGGAGCCCAACAA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5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51763240"/>
                  </a:ext>
                </a:extLst>
              </a:tr>
              <a:tr h="152476"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CACGCAGAGTCCGCAAAAT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9038" marR="39038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46243221"/>
                  </a:ext>
                </a:extLst>
              </a:tr>
            </a:tbl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id="{C044E68F-6663-1CE2-5FAB-19CAAB9E3E60}"/>
              </a:ext>
            </a:extLst>
          </p:cNvPr>
          <p:cNvSpPr txBox="1"/>
          <p:nvPr/>
        </p:nvSpPr>
        <p:spPr>
          <a:xfrm>
            <a:off x="258618" y="5791200"/>
            <a:ext cx="118317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Table S1. </a:t>
            </a:r>
            <a:r>
              <a:rPr lang="en-US" altLang="zh-CN" sz="1400" dirty="0">
                <a:latin typeface="Calibri" panose="020F0502020204030204" pitchFamily="34" charset="0"/>
                <a:cs typeface="Calibri" panose="020F0502020204030204" pitchFamily="34" charset="0"/>
              </a:rPr>
              <a:t>Primers applied in this work.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9016843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9</TotalTime>
  <Words>365</Words>
  <Application>Microsoft Office PowerPoint</Application>
  <PresentationFormat>宽屏</PresentationFormat>
  <Paragraphs>94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TimesTen-Roman</vt:lpstr>
      <vt:lpstr>等线</vt:lpstr>
      <vt:lpstr>等线 Light</vt:lpstr>
      <vt:lpstr>Arial</vt:lpstr>
      <vt:lpstr>Calibri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enjing shi</dc:creator>
  <cp:lastModifiedBy>wenjing shi</cp:lastModifiedBy>
  <cp:revision>7</cp:revision>
  <dcterms:created xsi:type="dcterms:W3CDTF">2022-05-17T17:14:26Z</dcterms:created>
  <dcterms:modified xsi:type="dcterms:W3CDTF">2022-09-08T13:41:51Z</dcterms:modified>
</cp:coreProperties>
</file>